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Default Extension="emf" ContentType="image/x-emf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6"/>
  </p:notesMasterIdLst>
  <p:sldIdLst>
    <p:sldId id="265" r:id="rId2"/>
    <p:sldId id="281" r:id="rId3"/>
    <p:sldId id="279" r:id="rId4"/>
    <p:sldId id="280" r:id="rId5"/>
    <p:sldId id="286" r:id="rId6"/>
    <p:sldId id="282" r:id="rId7"/>
    <p:sldId id="283" r:id="rId8"/>
    <p:sldId id="273" r:id="rId9"/>
    <p:sldId id="284" r:id="rId10"/>
    <p:sldId id="278" r:id="rId11"/>
    <p:sldId id="287" r:id="rId12"/>
    <p:sldId id="275" r:id="rId13"/>
    <p:sldId id="266" r:id="rId14"/>
    <p:sldId id="285" r:id="rId1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y Rezvani" initials="" lastIdx="3" clrIdx="0"/>
  <p:cmAuthor id="1" name="Hila shaim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83" autoAdjust="0"/>
  </p:normalViewPr>
  <p:slideViewPr>
    <p:cSldViewPr snapToGrid="0" snapToObjects="1">
      <p:cViewPr>
        <p:scale>
          <a:sx n="81" d="100"/>
          <a:sy n="81" d="100"/>
        </p:scale>
        <p:origin x="-904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commentAuthors" Target="commentAuthors.xml"/><Relationship Id="rId8" Type="http://schemas.openxmlformats.org/officeDocument/2006/relationships/slide" Target="slides/slide7.xml"/><Relationship Id="rId21" Type="http://schemas.openxmlformats.org/officeDocument/2006/relationships/theme" Target="theme/theme1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printerSettings" Target="printerSettings/printerSettings1.bin"/><Relationship Id="rId7" Type="http://schemas.openxmlformats.org/officeDocument/2006/relationships/slide" Target="slides/slide6.xml"/><Relationship Id="rId25" Type="http://schemas.openxmlformats.org/officeDocument/2006/relationships/customXml" Target="../customXml/item3.xml"/><Relationship Id="rId20" Type="http://schemas.openxmlformats.org/officeDocument/2006/relationships/viewProps" Target="viewProps.xml"/><Relationship Id="rId16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1" Type="http://schemas.openxmlformats.org/officeDocument/2006/relationships/slide" Target="slides/slide1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24" Type="http://schemas.openxmlformats.org/officeDocument/2006/relationships/customXml" Target="../customXml/item2.xml"/><Relationship Id="rId15" Type="http://schemas.openxmlformats.org/officeDocument/2006/relationships/slide" Target="slides/slide14.xml"/><Relationship Id="rId5" Type="http://schemas.openxmlformats.org/officeDocument/2006/relationships/slide" Target="slides/slide4.xml"/><Relationship Id="rId23" Type="http://schemas.openxmlformats.org/officeDocument/2006/relationships/customXml" Target="../customXml/item1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9" Type="http://schemas.openxmlformats.org/officeDocument/2006/relationships/slide" Target="slides/slide8.xml"/><Relationship Id="rId22" Type="http://schemas.openxmlformats.org/officeDocument/2006/relationships/tableStyles" Target="tableStyles.xml"/><Relationship Id="rId14" Type="http://schemas.openxmlformats.org/officeDocument/2006/relationships/slide" Target="slides/slide13.xml"/><Relationship Id="rId4" Type="http://schemas.openxmlformats.org/officeDocument/2006/relationships/slide" Target="slides/slide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986760-4153-1B4C-BEC9-E0DFB5467D57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D4A4EA-23A3-A74C-8DCD-50C4FF489F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48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788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606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550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863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491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373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681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795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87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14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851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27FC4-33C4-C340-92FD-0F664709EB35}" type="datetimeFigureOut">
              <a:rPr lang="en-US" smtClean="0"/>
              <a:t>11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310C6-E470-474A-A939-FCFA6A9E4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024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4" Type="http://schemas.openxmlformats.org/officeDocument/2006/relationships/image" Target="../media/image39.png"/><Relationship Id="rId5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4" Type="http://schemas.openxmlformats.org/officeDocument/2006/relationships/image" Target="../media/image43.png"/><Relationship Id="rId5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4" Type="http://schemas.openxmlformats.org/officeDocument/2006/relationships/image" Target="../media/image47.png"/><Relationship Id="rId5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5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4" Type="http://schemas.openxmlformats.org/officeDocument/2006/relationships/image" Target="../media/image51.png"/><Relationship Id="rId5" Type="http://schemas.openxmlformats.org/officeDocument/2006/relationships/image" Target="../media/image52.png"/><Relationship Id="rId6" Type="http://schemas.openxmlformats.org/officeDocument/2006/relationships/image" Target="../media/image53.png"/><Relationship Id="rId7" Type="http://schemas.openxmlformats.org/officeDocument/2006/relationships/image" Target="../media/image54.png"/><Relationship Id="rId8" Type="http://schemas.openxmlformats.org/officeDocument/2006/relationships/image" Target="../media/image55.png"/><Relationship Id="rId9" Type="http://schemas.openxmlformats.org/officeDocument/2006/relationships/image" Target="../media/image5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emf"/><Relationship Id="rId6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emf"/><Relationship Id="rId5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image" Target="../media/image26.png"/><Relationship Id="rId6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3828554" y="1727743"/>
            <a:ext cx="341908" cy="255719"/>
          </a:xfrm>
          <a:prstGeom prst="rect">
            <a:avLst/>
          </a:prstGeom>
          <a:solidFill>
            <a:schemeClr val="bg1">
              <a:lumMod val="85000"/>
              <a:alpha val="4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3828554" y="1364339"/>
            <a:ext cx="341908" cy="25571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3828554" y="2064687"/>
            <a:ext cx="341908" cy="255719"/>
          </a:xfrm>
          <a:prstGeom prst="rect">
            <a:avLst/>
          </a:prstGeom>
          <a:solidFill>
            <a:schemeClr val="bg1">
              <a:lumMod val="65000"/>
              <a:alpha val="50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4294213" y="1218227"/>
            <a:ext cx="6451481" cy="40395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3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 99.6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</a:t>
            </a:r>
            <a:r>
              <a:rPr lang="en-US" dirty="0"/>
              <a:t> </a:t>
            </a:r>
            <a:r>
              <a:rPr lang="en-US" dirty="0" smtClean="0"/>
              <a:t>baseline                                                     102                                                         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5m                                            112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10m                                          113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15m                                          137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20m                                          125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30m                                          130</a:t>
            </a:r>
          </a:p>
          <a:p>
            <a:pPr>
              <a:lnSpc>
                <a:spcPct val="130000"/>
              </a:lnSpc>
            </a:pPr>
            <a:r>
              <a:rPr lang="en-US" dirty="0" smtClean="0"/>
              <a:t>CLL+ CXCL12- 45m                                          136</a:t>
            </a:r>
          </a:p>
          <a:p>
            <a:pPr>
              <a:lnSpc>
                <a:spcPct val="130000"/>
              </a:lnSpc>
            </a:pPr>
            <a:r>
              <a:rPr lang="en-US" dirty="0"/>
              <a:t>CLL+ CXCL12- </a:t>
            </a:r>
            <a:r>
              <a:rPr lang="en-US" dirty="0" smtClean="0"/>
              <a:t>1h                                             121 </a:t>
            </a:r>
          </a:p>
          <a:p>
            <a:pPr>
              <a:lnSpc>
                <a:spcPct val="130000"/>
              </a:lnSpc>
            </a:pPr>
            <a:endParaRPr lang="en-US" dirty="0" smtClean="0"/>
          </a:p>
          <a:p>
            <a:pPr>
              <a:lnSpc>
                <a:spcPct val="130000"/>
              </a:lnSpc>
            </a:pP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23749" y="0"/>
            <a:ext cx="226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1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17134" y="500604"/>
            <a:ext cx="427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11481" y="440145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-Y705-STAT3- PE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8211568" y="995007"/>
            <a:ext cx="653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FI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r="58393" b="4308"/>
          <a:stretch/>
        </p:blipFill>
        <p:spPr>
          <a:xfrm>
            <a:off x="-401538" y="995007"/>
            <a:ext cx="3804530" cy="3591693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3828554" y="2426046"/>
            <a:ext cx="341908" cy="255719"/>
          </a:xfrm>
          <a:prstGeom prst="rect">
            <a:avLst/>
          </a:prstGeom>
          <a:solidFill>
            <a:schemeClr val="bg1">
              <a:lumMod val="50000"/>
              <a:alpha val="64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831584" y="2778894"/>
            <a:ext cx="341908" cy="255719"/>
          </a:xfrm>
          <a:prstGeom prst="rect">
            <a:avLst/>
          </a:prstGeom>
          <a:solidFill>
            <a:schemeClr val="tx1">
              <a:lumMod val="65000"/>
              <a:lumOff val="35000"/>
              <a:alpha val="64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3828554" y="3139379"/>
            <a:ext cx="341908" cy="255719"/>
          </a:xfrm>
          <a:prstGeom prst="rect">
            <a:avLst/>
          </a:prstGeom>
          <a:solidFill>
            <a:schemeClr val="tx1">
              <a:lumMod val="75000"/>
              <a:lumOff val="25000"/>
              <a:alpha val="64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3834614" y="3498182"/>
            <a:ext cx="341908" cy="255719"/>
          </a:xfrm>
          <a:prstGeom prst="rect">
            <a:avLst/>
          </a:prstGeom>
          <a:solidFill>
            <a:schemeClr val="tx1">
              <a:lumMod val="85000"/>
              <a:lumOff val="15000"/>
              <a:alpha val="64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834614" y="3840086"/>
            <a:ext cx="341908" cy="255719"/>
          </a:xfrm>
          <a:prstGeom prst="rect">
            <a:avLst/>
          </a:prstGeom>
          <a:solidFill>
            <a:schemeClr val="tx1">
              <a:lumMod val="85000"/>
              <a:lumOff val="15000"/>
              <a:alpha val="79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834614" y="4186560"/>
            <a:ext cx="341908" cy="255719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313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2"/>
          <a:srcRect l="7511" b="4265"/>
          <a:stretch/>
        </p:blipFill>
        <p:spPr>
          <a:xfrm>
            <a:off x="3481896" y="156206"/>
            <a:ext cx="1483580" cy="1520195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3"/>
          <a:srcRect l="8205" b="5228"/>
          <a:stretch/>
        </p:blipFill>
        <p:spPr>
          <a:xfrm>
            <a:off x="2024103" y="156206"/>
            <a:ext cx="1476069" cy="1496846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/>
          <a:srcRect l="8951" b="5606"/>
          <a:stretch/>
        </p:blipFill>
        <p:spPr>
          <a:xfrm>
            <a:off x="3500172" y="1813624"/>
            <a:ext cx="1451842" cy="1468141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5"/>
          <a:srcRect l="8827" b="6223"/>
          <a:stretch/>
        </p:blipFill>
        <p:spPr>
          <a:xfrm>
            <a:off x="2024103" y="1787244"/>
            <a:ext cx="1476069" cy="148085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6"/>
          <a:srcRect l="5900" b="5283"/>
          <a:stretch/>
        </p:blipFill>
        <p:spPr>
          <a:xfrm>
            <a:off x="3439497" y="3559322"/>
            <a:ext cx="1506774" cy="148009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/>
          <a:srcRect l="8895" b="5283"/>
          <a:stretch/>
        </p:blipFill>
        <p:spPr>
          <a:xfrm>
            <a:off x="2040744" y="3559322"/>
            <a:ext cx="1459428" cy="148009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8"/>
          <a:srcRect l="8453" b="5283"/>
          <a:stretch/>
        </p:blipFill>
        <p:spPr>
          <a:xfrm>
            <a:off x="3500172" y="5222884"/>
            <a:ext cx="1446098" cy="145538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9"/>
          <a:srcRect l="10472" b="4598"/>
          <a:stretch/>
        </p:blipFill>
        <p:spPr>
          <a:xfrm>
            <a:off x="2076142" y="5222885"/>
            <a:ext cx="1424030" cy="1480095"/>
          </a:xfrm>
          <a:prstGeom prst="rect">
            <a:avLst/>
          </a:prstGeom>
        </p:spPr>
      </p:pic>
      <p:cxnSp>
        <p:nvCxnSpPr>
          <p:cNvPr id="26" name="Straight Arrow Connector 25"/>
          <p:cNvCxnSpPr/>
          <p:nvPr/>
        </p:nvCxnSpPr>
        <p:spPr>
          <a:xfrm flipV="1">
            <a:off x="1980874" y="0"/>
            <a:ext cx="0" cy="667826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1962289" y="1654804"/>
            <a:ext cx="3166567" cy="2159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1965933" y="3284090"/>
            <a:ext cx="3162923" cy="2471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1962289" y="5039417"/>
            <a:ext cx="3166567" cy="247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1944728" y="6678269"/>
            <a:ext cx="318412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666054" y="1576212"/>
            <a:ext cx="19307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D107a- PE-CF594</a:t>
            </a:r>
            <a:endParaRPr lang="en-US" sz="1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3089102" y="3250930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NFα- A700</a:t>
            </a:r>
            <a:endParaRPr lang="en-US" sz="1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3089102" y="4993329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 smtClean="0"/>
              <a:t>IFNγ</a:t>
            </a:r>
            <a:r>
              <a:rPr lang="en-US" sz="1600" b="1" dirty="0" smtClean="0"/>
              <a:t>- V450</a:t>
            </a:r>
            <a:endParaRPr lang="en-US" sz="1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3391027" y="6586411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IL-2</a:t>
            </a:r>
            <a:endParaRPr lang="en-US" sz="1600" b="1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1033857" y="3183135"/>
            <a:ext cx="1494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D3- BV650</a:t>
            </a:r>
            <a:endParaRPr lang="en-US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2474107" y="-8902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 </a:t>
            </a:r>
            <a:endParaRPr lang="en-US" sz="1400" dirty="0"/>
          </a:p>
        </p:txBody>
      </p:sp>
      <p:sp>
        <p:nvSpPr>
          <p:cNvPr id="56" name="TextBox 55"/>
          <p:cNvSpPr txBox="1"/>
          <p:nvPr/>
        </p:nvSpPr>
        <p:spPr>
          <a:xfrm>
            <a:off x="2851409" y="253044"/>
            <a:ext cx="6304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5.8%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2851409" y="1903984"/>
            <a:ext cx="5564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0.1%</a:t>
            </a:r>
            <a:endParaRPr lang="en-US" sz="1200" dirty="0"/>
          </a:p>
        </p:txBody>
      </p:sp>
      <p:sp>
        <p:nvSpPr>
          <p:cNvPr id="68" name="TextBox 67"/>
          <p:cNvSpPr txBox="1"/>
          <p:nvPr/>
        </p:nvSpPr>
        <p:spPr>
          <a:xfrm>
            <a:off x="2851409" y="3612533"/>
            <a:ext cx="56998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2.3%</a:t>
            </a:r>
            <a:endParaRPr lang="en-US" sz="1200" dirty="0"/>
          </a:p>
        </p:txBody>
      </p:sp>
      <p:sp>
        <p:nvSpPr>
          <p:cNvPr id="69" name="TextBox 68"/>
          <p:cNvSpPr txBox="1"/>
          <p:nvPr/>
        </p:nvSpPr>
        <p:spPr>
          <a:xfrm>
            <a:off x="4322384" y="3627752"/>
            <a:ext cx="58760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3.8%</a:t>
            </a:r>
            <a:endParaRPr lang="en-US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2862057" y="5299776"/>
            <a:ext cx="6853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7.2%</a:t>
            </a:r>
            <a:endParaRPr lang="en-US" sz="1200" dirty="0"/>
          </a:p>
        </p:txBody>
      </p:sp>
      <p:sp>
        <p:nvSpPr>
          <p:cNvPr id="77" name="TextBox 76"/>
          <p:cNvSpPr txBox="1"/>
          <p:nvPr/>
        </p:nvSpPr>
        <p:spPr>
          <a:xfrm>
            <a:off x="4336994" y="5299776"/>
            <a:ext cx="628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8.3%</a:t>
            </a:r>
            <a:endParaRPr lang="en-US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4320900" y="1898452"/>
            <a:ext cx="5564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1%</a:t>
            </a:r>
            <a:endParaRPr lang="en-US" sz="1200" dirty="0"/>
          </a:p>
        </p:txBody>
      </p:sp>
      <p:sp>
        <p:nvSpPr>
          <p:cNvPr id="82" name="TextBox 81"/>
          <p:cNvSpPr txBox="1"/>
          <p:nvPr/>
        </p:nvSpPr>
        <p:spPr>
          <a:xfrm>
            <a:off x="4320900" y="231394"/>
            <a:ext cx="6304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6.6%</a:t>
            </a:r>
            <a:endParaRPr lang="en-US" sz="1200" dirty="0"/>
          </a:p>
        </p:txBody>
      </p:sp>
      <p:sp>
        <p:nvSpPr>
          <p:cNvPr id="83" name="TextBox 82"/>
          <p:cNvSpPr txBox="1"/>
          <p:nvPr/>
        </p:nvSpPr>
        <p:spPr>
          <a:xfrm>
            <a:off x="3613714" y="-83166"/>
            <a:ext cx="1515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+ CXCL12 </a:t>
            </a:r>
            <a:endParaRPr 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0" y="0"/>
            <a:ext cx="2269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</a:p>
          <a:p>
            <a:r>
              <a:rPr lang="en-US" b="1" dirty="0" smtClean="0"/>
              <a:t>Fig. </a:t>
            </a:r>
            <a:r>
              <a:rPr lang="en-US" b="1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41966858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0" y="0"/>
            <a:ext cx="2269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</a:p>
          <a:p>
            <a:r>
              <a:rPr lang="en-US" b="1" dirty="0" smtClean="0"/>
              <a:t>Fig. </a:t>
            </a:r>
            <a:r>
              <a:rPr lang="en-US" b="1" dirty="0"/>
              <a:t>7</a:t>
            </a:r>
            <a:endParaRPr lang="en-US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425" r="51993" b="5932"/>
          <a:stretch/>
        </p:blipFill>
        <p:spPr>
          <a:xfrm>
            <a:off x="141100" y="964699"/>
            <a:ext cx="2398682" cy="2279314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 rotWithShape="1">
          <a:blip r:embed="rId3"/>
          <a:srcRect l="4927" r="52158" b="3961"/>
          <a:stretch/>
        </p:blipFill>
        <p:spPr>
          <a:xfrm>
            <a:off x="3131842" y="964699"/>
            <a:ext cx="2313528" cy="227931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3429" r="54565" b="4678"/>
          <a:stretch/>
        </p:blipFill>
        <p:spPr>
          <a:xfrm>
            <a:off x="6035898" y="964699"/>
            <a:ext cx="2356874" cy="2279314"/>
          </a:xfrm>
          <a:prstGeom prst="rect">
            <a:avLst/>
          </a:prstGeom>
        </p:spPr>
      </p:pic>
      <p:cxnSp>
        <p:nvCxnSpPr>
          <p:cNvPr id="36" name="Straight Arrow Connector 35"/>
          <p:cNvCxnSpPr/>
          <p:nvPr/>
        </p:nvCxnSpPr>
        <p:spPr>
          <a:xfrm>
            <a:off x="141100" y="3315792"/>
            <a:ext cx="8481618" cy="2471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3872389" y="3358993"/>
            <a:ext cx="3088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FSE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1685" y="1552311"/>
            <a:ext cx="10347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83.9%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3413353" y="1496473"/>
            <a:ext cx="10347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83.5%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6443524" y="1491234"/>
            <a:ext cx="10347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67.8%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1003016" y="704776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</a:t>
            </a:r>
            <a:r>
              <a:rPr lang="en-US" sz="1400" dirty="0" smtClean="0"/>
              <a:t>cells </a:t>
            </a:r>
            <a:endParaRPr 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3690513" y="713026"/>
            <a:ext cx="1515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+ </a:t>
            </a:r>
            <a:r>
              <a:rPr lang="en-US" sz="1400" dirty="0" smtClean="0"/>
              <a:t>CLL cells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6310266" y="704776"/>
            <a:ext cx="20459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+ </a:t>
            </a:r>
            <a:r>
              <a:rPr lang="en-US" sz="1400" dirty="0" smtClean="0"/>
              <a:t>CLL cells+ CXCL12 </a:t>
            </a:r>
            <a:endParaRPr lang="en-US" sz="1400" dirty="0"/>
          </a:p>
        </p:txBody>
      </p:sp>
      <p:pic>
        <p:nvPicPr>
          <p:cNvPr id="9" name="Picture 8" descr="CFSE assay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00"/>
          <a:stretch/>
        </p:blipFill>
        <p:spPr>
          <a:xfrm>
            <a:off x="1724552" y="4609892"/>
            <a:ext cx="5789617" cy="2248107"/>
          </a:xfrm>
          <a:prstGeom prst="rect">
            <a:avLst/>
          </a:prstGeom>
        </p:spPr>
      </p:pic>
      <p:cxnSp>
        <p:nvCxnSpPr>
          <p:cNvPr id="51" name="Straight Connector 50"/>
          <p:cNvCxnSpPr/>
          <p:nvPr/>
        </p:nvCxnSpPr>
        <p:spPr>
          <a:xfrm>
            <a:off x="3672696" y="4728121"/>
            <a:ext cx="104840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3672696" y="4682628"/>
            <a:ext cx="0" cy="8901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4721100" y="4683613"/>
            <a:ext cx="0" cy="890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733854" y="4409255"/>
            <a:ext cx="848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P=</a:t>
            </a:r>
            <a:r>
              <a:rPr lang="en-US" sz="1600" dirty="0" smtClean="0"/>
              <a:t>0.02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0525537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/>
          </p:cNvPicPr>
          <p:nvPr/>
        </p:nvPicPr>
        <p:blipFill rotWithShape="1">
          <a:blip r:embed="rId2"/>
          <a:srcRect r="56852" b="4246"/>
          <a:stretch/>
        </p:blipFill>
        <p:spPr>
          <a:xfrm>
            <a:off x="1097351" y="-78026"/>
            <a:ext cx="2252607" cy="173736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 rotWithShape="1">
          <a:blip r:embed="rId3"/>
          <a:srcRect r="57795" b="3122"/>
          <a:stretch/>
        </p:blipFill>
        <p:spPr>
          <a:xfrm>
            <a:off x="1097351" y="1532715"/>
            <a:ext cx="2315207" cy="175564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474896" y="6451681"/>
            <a:ext cx="1874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-S727-STAT3- PE</a:t>
            </a:r>
          </a:p>
        </p:txBody>
      </p:sp>
      <p:sp>
        <p:nvSpPr>
          <p:cNvPr id="9" name="Rectangle 8"/>
          <p:cNvSpPr/>
          <p:nvPr/>
        </p:nvSpPr>
        <p:spPr>
          <a:xfrm>
            <a:off x="3421674" y="581147"/>
            <a:ext cx="341908" cy="255719"/>
          </a:xfrm>
          <a:prstGeom prst="rect">
            <a:avLst/>
          </a:prstGeom>
          <a:solidFill>
            <a:schemeClr val="tx1">
              <a:alpha val="4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421674" y="217743"/>
            <a:ext cx="341908" cy="25571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421674" y="930420"/>
            <a:ext cx="341908" cy="25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3887333" y="147393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 145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 baseline                                                     402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CXCL12                                                    798</a:t>
            </a:r>
          </a:p>
          <a:p>
            <a:pPr>
              <a:lnSpc>
                <a:spcPct val="120000"/>
              </a:lnSpc>
            </a:pPr>
            <a:endParaRPr lang="en-US" dirty="0" smtClean="0"/>
          </a:p>
          <a:p>
            <a:pPr>
              <a:lnSpc>
                <a:spcPct val="120000"/>
              </a:lnSpc>
            </a:pP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-79110" y="0"/>
            <a:ext cx="2269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</a:p>
          <a:p>
            <a:r>
              <a:rPr lang="en-US" b="1" dirty="0" smtClean="0"/>
              <a:t>Fig. </a:t>
            </a:r>
            <a:r>
              <a:rPr lang="en-US" b="1" dirty="0"/>
              <a:t>8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7804689" y="-49316"/>
            <a:ext cx="653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FI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3450323" y="2128349"/>
            <a:ext cx="341908" cy="255719"/>
          </a:xfrm>
          <a:prstGeom prst="rect">
            <a:avLst/>
          </a:prstGeom>
          <a:solidFill>
            <a:schemeClr val="tx1">
              <a:alpha val="4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3450323" y="1764945"/>
            <a:ext cx="341908" cy="25571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450323" y="2477622"/>
            <a:ext cx="341908" cy="25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3915982" y="1694595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145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0.1μM </a:t>
            </a:r>
            <a:r>
              <a:rPr lang="en-US" dirty="0" err="1" smtClean="0"/>
              <a:t>lenalidomide</a:t>
            </a:r>
            <a:r>
              <a:rPr lang="en-US" dirty="0" smtClean="0"/>
              <a:t>                             380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</a:t>
            </a:r>
            <a:r>
              <a:rPr lang="en-US" dirty="0"/>
              <a:t>+0.1μM </a:t>
            </a:r>
            <a:r>
              <a:rPr lang="en-US" dirty="0" err="1" smtClean="0"/>
              <a:t>lenalidomide</a:t>
            </a:r>
            <a:r>
              <a:rPr lang="en-US" dirty="0" smtClean="0"/>
              <a:t>+   CXCL12           489</a:t>
            </a:r>
          </a:p>
          <a:p>
            <a:pPr>
              <a:lnSpc>
                <a:spcPct val="120000"/>
              </a:lnSpc>
            </a:pPr>
            <a:endParaRPr lang="en-US" dirty="0" smtClean="0"/>
          </a:p>
          <a:p>
            <a:pPr>
              <a:lnSpc>
                <a:spcPct val="120000"/>
              </a:lnSpc>
            </a:pPr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3434004" y="3873442"/>
            <a:ext cx="341908" cy="255719"/>
          </a:xfrm>
          <a:prstGeom prst="rect">
            <a:avLst/>
          </a:prstGeom>
          <a:solidFill>
            <a:schemeClr val="tx1">
              <a:alpha val="4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3434004" y="3510038"/>
            <a:ext cx="341908" cy="25571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434004" y="4222715"/>
            <a:ext cx="341908" cy="25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3899663" y="3439688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145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1μM </a:t>
            </a:r>
            <a:r>
              <a:rPr lang="en-US" dirty="0" err="1" smtClean="0"/>
              <a:t>lenalidomide</a:t>
            </a:r>
            <a:r>
              <a:rPr lang="en-US" dirty="0" smtClean="0"/>
              <a:t>                                360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</a:t>
            </a:r>
            <a:r>
              <a:rPr lang="en-US" dirty="0"/>
              <a:t>+ 1μM </a:t>
            </a:r>
            <a:r>
              <a:rPr lang="en-US" dirty="0" err="1" smtClean="0"/>
              <a:t>lenalidomide</a:t>
            </a:r>
            <a:r>
              <a:rPr lang="en-US" dirty="0" smtClean="0"/>
              <a:t>+ CXCL12               486</a:t>
            </a:r>
          </a:p>
          <a:p>
            <a:pPr>
              <a:lnSpc>
                <a:spcPct val="120000"/>
              </a:lnSpc>
            </a:pPr>
            <a:endParaRPr lang="en-US" dirty="0" smtClean="0"/>
          </a:p>
          <a:p>
            <a:pPr>
              <a:lnSpc>
                <a:spcPct val="120000"/>
              </a:lnSpc>
            </a:pPr>
            <a:endParaRPr lang="en-US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/>
          <a:srcRect l="6384" r="57488" b="5534"/>
          <a:stretch/>
        </p:blipFill>
        <p:spPr>
          <a:xfrm>
            <a:off x="1441120" y="3145966"/>
            <a:ext cx="1983768" cy="1755648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3462653" y="5506703"/>
            <a:ext cx="341908" cy="255719"/>
          </a:xfrm>
          <a:prstGeom prst="rect">
            <a:avLst/>
          </a:prstGeom>
          <a:solidFill>
            <a:schemeClr val="tx1">
              <a:alpha val="4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462653" y="5143299"/>
            <a:ext cx="341908" cy="255719"/>
          </a:xfrm>
          <a:prstGeom prst="rect">
            <a:avLst/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462653" y="5855976"/>
            <a:ext cx="341908" cy="25571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3928312" y="5072949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145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10μM </a:t>
            </a:r>
            <a:r>
              <a:rPr lang="en-US" dirty="0" err="1" smtClean="0"/>
              <a:t>lenalidomide</a:t>
            </a:r>
            <a:r>
              <a:rPr lang="en-US" dirty="0" smtClean="0"/>
              <a:t>                              364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</a:t>
            </a:r>
            <a:r>
              <a:rPr lang="en-US" dirty="0"/>
              <a:t>+ </a:t>
            </a:r>
            <a:r>
              <a:rPr lang="en-US" dirty="0" smtClean="0"/>
              <a:t>10μM </a:t>
            </a:r>
            <a:r>
              <a:rPr lang="en-US" dirty="0" err="1" smtClean="0"/>
              <a:t>lenalidomide</a:t>
            </a:r>
            <a:r>
              <a:rPr lang="en-US" dirty="0" smtClean="0"/>
              <a:t>+ CXCL12             </a:t>
            </a:r>
            <a:r>
              <a:rPr lang="en-US" dirty="0"/>
              <a:t>3</a:t>
            </a:r>
            <a:r>
              <a:rPr lang="en-US" dirty="0" smtClean="0"/>
              <a:t>80</a:t>
            </a:r>
          </a:p>
          <a:p>
            <a:pPr>
              <a:lnSpc>
                <a:spcPct val="120000"/>
              </a:lnSpc>
            </a:pPr>
            <a:endParaRPr lang="en-US" dirty="0" smtClean="0"/>
          </a:p>
          <a:p>
            <a:pPr>
              <a:lnSpc>
                <a:spcPct val="120000"/>
              </a:lnSpc>
            </a:pPr>
            <a:endParaRPr lang="en-US" dirty="0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/>
          <a:srcRect r="57040" b="3996"/>
          <a:stretch/>
        </p:blipFill>
        <p:spPr>
          <a:xfrm>
            <a:off x="1096116" y="4864627"/>
            <a:ext cx="2336652" cy="1755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79987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Western blot- pS727-STAT3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17"/>
          <a:stretch/>
        </p:blipFill>
        <p:spPr>
          <a:xfrm>
            <a:off x="792537" y="3604141"/>
            <a:ext cx="5177267" cy="325385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255059" y="664545"/>
            <a:ext cx="70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.37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077894" y="66619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.66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99327" y="663884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.42 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774942" y="668138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.39 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409931" y="2322731"/>
            <a:ext cx="762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409931" y="1789331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AT3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409931" y="1107678"/>
            <a:ext cx="1656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r>
              <a:rPr lang="en-US" dirty="0" smtClean="0"/>
              <a:t>-S727-STAT3</a:t>
            </a:r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2366754" y="3649634"/>
            <a:ext cx="104840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2366754" y="3604141"/>
            <a:ext cx="0" cy="8901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415158" y="3605126"/>
            <a:ext cx="0" cy="890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427912" y="3330768"/>
            <a:ext cx="848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P=0.04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1374097" y="368980"/>
            <a:ext cx="58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LL</a:t>
            </a:r>
            <a:endParaRPr lang="en-US" sz="1100" dirty="0"/>
          </a:p>
        </p:txBody>
      </p:sp>
      <p:sp>
        <p:nvSpPr>
          <p:cNvPr id="28" name="TextBox 27"/>
          <p:cNvSpPr txBox="1"/>
          <p:nvPr/>
        </p:nvSpPr>
        <p:spPr>
          <a:xfrm>
            <a:off x="1957267" y="377287"/>
            <a:ext cx="8187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+CXCL12</a:t>
            </a:r>
            <a:endParaRPr lang="en-US" sz="1100" dirty="0"/>
          </a:p>
        </p:txBody>
      </p:sp>
      <p:sp>
        <p:nvSpPr>
          <p:cNvPr id="29" name="TextBox 28"/>
          <p:cNvSpPr txBox="1"/>
          <p:nvPr/>
        </p:nvSpPr>
        <p:spPr>
          <a:xfrm>
            <a:off x="2532499" y="368980"/>
            <a:ext cx="1077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+</a:t>
            </a:r>
            <a:r>
              <a:rPr lang="en-US" sz="1100" dirty="0" err="1" smtClean="0"/>
              <a:t>lenalidomide</a:t>
            </a:r>
            <a:endParaRPr lang="en-US" sz="1100" dirty="0"/>
          </a:p>
        </p:txBody>
      </p:sp>
      <p:sp>
        <p:nvSpPr>
          <p:cNvPr id="30" name="TextBox 29"/>
          <p:cNvSpPr txBox="1"/>
          <p:nvPr/>
        </p:nvSpPr>
        <p:spPr>
          <a:xfrm>
            <a:off x="3447827" y="368980"/>
            <a:ext cx="107728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+</a:t>
            </a:r>
            <a:r>
              <a:rPr lang="en-US" sz="1100" dirty="0" err="1" smtClean="0"/>
              <a:t>lenalidomide</a:t>
            </a:r>
            <a:endParaRPr lang="en-US" sz="1100" dirty="0" smtClean="0"/>
          </a:p>
          <a:p>
            <a:pPr algn="ctr"/>
            <a:r>
              <a:rPr lang="en-US" sz="1100" dirty="0" smtClean="0"/>
              <a:t>+CXCL12</a:t>
            </a:r>
            <a:endParaRPr lang="en-US" sz="1100" dirty="0"/>
          </a:p>
        </p:txBody>
      </p:sp>
      <p:sp>
        <p:nvSpPr>
          <p:cNvPr id="31" name="TextBox 30"/>
          <p:cNvSpPr txBox="1"/>
          <p:nvPr/>
        </p:nvSpPr>
        <p:spPr>
          <a:xfrm>
            <a:off x="23749" y="0"/>
            <a:ext cx="226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</a:t>
            </a:r>
            <a:r>
              <a:rPr lang="en-US" b="1" dirty="0"/>
              <a:t>9</a:t>
            </a:r>
            <a:endParaRPr lang="en-US" b="1" dirty="0"/>
          </a:p>
        </p:txBody>
      </p:sp>
      <p:pic>
        <p:nvPicPr>
          <p:cNvPr id="3" name="Picture 2" descr="Screen Shot 2017-03-03 at 1.04.05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9027" y="1163790"/>
            <a:ext cx="3420903" cy="454348"/>
          </a:xfrm>
          <a:prstGeom prst="rect">
            <a:avLst/>
          </a:prstGeom>
        </p:spPr>
      </p:pic>
      <p:pic>
        <p:nvPicPr>
          <p:cNvPr id="4" name="Picture 3" descr="Screen Shot 2017-03-03 at 1.04.50 PM.png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9027" y="2341491"/>
            <a:ext cx="3442590" cy="432804"/>
          </a:xfrm>
          <a:prstGeom prst="rect">
            <a:avLst/>
          </a:prstGeom>
        </p:spPr>
      </p:pic>
      <p:pic>
        <p:nvPicPr>
          <p:cNvPr id="18" name="Picture 17" descr="Screen Shot 2017-03-03 at 1.17.01 PM.png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90" b="-1"/>
          <a:stretch/>
        </p:blipFill>
        <p:spPr>
          <a:xfrm>
            <a:off x="1006667" y="1711009"/>
            <a:ext cx="3417110" cy="456079"/>
          </a:xfrm>
          <a:prstGeom prst="rect">
            <a:avLst/>
          </a:prstGeom>
        </p:spPr>
      </p:pic>
      <p:cxnSp>
        <p:nvCxnSpPr>
          <p:cNvPr id="32" name="Straight Connector 31"/>
          <p:cNvCxnSpPr/>
          <p:nvPr/>
        </p:nvCxnSpPr>
        <p:spPr>
          <a:xfrm>
            <a:off x="4296450" y="3651508"/>
            <a:ext cx="104840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4296450" y="3606015"/>
            <a:ext cx="0" cy="8901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5344854" y="3607000"/>
            <a:ext cx="0" cy="890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417372" y="3332642"/>
            <a:ext cx="8486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P=0.7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3235234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2"/>
          <a:srcRect l="10327" b="13203"/>
          <a:stretch/>
        </p:blipFill>
        <p:spPr>
          <a:xfrm>
            <a:off x="3807271" y="5057272"/>
            <a:ext cx="1704034" cy="1620997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/>
          <a:srcRect l="10281" t="3303" b="12558"/>
          <a:stretch/>
        </p:blipFill>
        <p:spPr>
          <a:xfrm>
            <a:off x="3796290" y="3374800"/>
            <a:ext cx="1726199" cy="165859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/>
          <a:srcRect l="11537" b="13928"/>
          <a:stretch/>
        </p:blipFill>
        <p:spPr>
          <a:xfrm>
            <a:off x="2133898" y="3388069"/>
            <a:ext cx="1659122" cy="163837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5"/>
          <a:srcRect l="8914" t="-11437" b="13248"/>
          <a:stretch/>
        </p:blipFill>
        <p:spPr>
          <a:xfrm>
            <a:off x="3722396" y="-217595"/>
            <a:ext cx="1757159" cy="185913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/>
          <a:srcRect l="9221" b="11922"/>
          <a:stretch/>
        </p:blipFill>
        <p:spPr>
          <a:xfrm>
            <a:off x="3722397" y="1640454"/>
            <a:ext cx="1788908" cy="166499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/>
          <a:srcRect l="10005" b="13546"/>
          <a:stretch/>
        </p:blipFill>
        <p:spPr>
          <a:xfrm>
            <a:off x="2121473" y="5073683"/>
            <a:ext cx="1631618" cy="157992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8"/>
          <a:srcRect l="9561" b="13519"/>
          <a:stretch/>
        </p:blipFill>
        <p:spPr>
          <a:xfrm>
            <a:off x="2088759" y="1654804"/>
            <a:ext cx="1734704" cy="16292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9"/>
          <a:srcRect l="9607" b="12176"/>
          <a:stretch/>
        </p:blipFill>
        <p:spPr>
          <a:xfrm>
            <a:off x="2091778" y="0"/>
            <a:ext cx="1728921" cy="1678269"/>
          </a:xfrm>
          <a:prstGeom prst="rect">
            <a:avLst/>
          </a:prstGeom>
        </p:spPr>
      </p:pic>
      <p:cxnSp>
        <p:nvCxnSpPr>
          <p:cNvPr id="26" name="Straight Arrow Connector 25"/>
          <p:cNvCxnSpPr/>
          <p:nvPr/>
        </p:nvCxnSpPr>
        <p:spPr>
          <a:xfrm flipV="1">
            <a:off x="2033332" y="0"/>
            <a:ext cx="0" cy="667826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2029688" y="1654804"/>
            <a:ext cx="3449867" cy="2346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2033332" y="3284090"/>
            <a:ext cx="3446223" cy="2471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V="1">
            <a:off x="2029688" y="5033396"/>
            <a:ext cx="3481617" cy="602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2012127" y="6678269"/>
            <a:ext cx="346742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 rot="16200000">
            <a:off x="1101256" y="3183135"/>
            <a:ext cx="14948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CD3- BV650</a:t>
            </a:r>
            <a:endParaRPr lang="en-US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2961834" y="229066"/>
            <a:ext cx="6858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2.6%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4692309" y="223936"/>
            <a:ext cx="61518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4.1%</a:t>
            </a:r>
            <a:endParaRPr lang="en-US" sz="1200" dirty="0"/>
          </a:p>
        </p:txBody>
      </p:sp>
      <p:sp>
        <p:nvSpPr>
          <p:cNvPr id="62" name="TextBox 61"/>
          <p:cNvSpPr txBox="1"/>
          <p:nvPr/>
        </p:nvSpPr>
        <p:spPr>
          <a:xfrm>
            <a:off x="3011146" y="1847226"/>
            <a:ext cx="6699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6.1%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2346371" y="2767858"/>
            <a:ext cx="4069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65" name="TextBox 64"/>
          <p:cNvSpPr txBox="1"/>
          <p:nvPr/>
        </p:nvSpPr>
        <p:spPr>
          <a:xfrm>
            <a:off x="4744684" y="1847383"/>
            <a:ext cx="57688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25.5%</a:t>
            </a:r>
            <a:endParaRPr lang="en-US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6374798" y="2778227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67" name="TextBox 66"/>
          <p:cNvSpPr txBox="1"/>
          <p:nvPr/>
        </p:nvSpPr>
        <p:spPr>
          <a:xfrm>
            <a:off x="4316650" y="2778227"/>
            <a:ext cx="4572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68" name="TextBox 67"/>
          <p:cNvSpPr txBox="1"/>
          <p:nvPr/>
        </p:nvSpPr>
        <p:spPr>
          <a:xfrm>
            <a:off x="2980372" y="3612533"/>
            <a:ext cx="66996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8.6%</a:t>
            </a:r>
            <a:endParaRPr lang="en-US" sz="1200" dirty="0"/>
          </a:p>
        </p:txBody>
      </p:sp>
      <p:sp>
        <p:nvSpPr>
          <p:cNvPr id="70" name="TextBox 69"/>
          <p:cNvSpPr txBox="1"/>
          <p:nvPr/>
        </p:nvSpPr>
        <p:spPr>
          <a:xfrm>
            <a:off x="4705726" y="3556157"/>
            <a:ext cx="63172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7.1%</a:t>
            </a:r>
            <a:endParaRPr lang="en-US" sz="1200" dirty="0"/>
          </a:p>
        </p:txBody>
      </p:sp>
      <p:sp>
        <p:nvSpPr>
          <p:cNvPr id="71" name="TextBox 70"/>
          <p:cNvSpPr txBox="1"/>
          <p:nvPr/>
        </p:nvSpPr>
        <p:spPr>
          <a:xfrm>
            <a:off x="2394846" y="4572000"/>
            <a:ext cx="47463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72" name="TextBox 71"/>
          <p:cNvSpPr txBox="1"/>
          <p:nvPr/>
        </p:nvSpPr>
        <p:spPr>
          <a:xfrm>
            <a:off x="4316650" y="4572000"/>
            <a:ext cx="47463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73" name="TextBox 72"/>
          <p:cNvSpPr txBox="1"/>
          <p:nvPr/>
        </p:nvSpPr>
        <p:spPr>
          <a:xfrm>
            <a:off x="6330173" y="3612533"/>
            <a:ext cx="29405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900" dirty="0"/>
          </a:p>
        </p:txBody>
      </p:sp>
      <p:sp>
        <p:nvSpPr>
          <p:cNvPr id="74" name="TextBox 73"/>
          <p:cNvSpPr txBox="1"/>
          <p:nvPr/>
        </p:nvSpPr>
        <p:spPr>
          <a:xfrm>
            <a:off x="3057863" y="5316689"/>
            <a:ext cx="5593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7.1%</a:t>
            </a:r>
            <a:endParaRPr lang="en-US" sz="1200" dirty="0"/>
          </a:p>
        </p:txBody>
      </p:sp>
      <p:sp>
        <p:nvSpPr>
          <p:cNvPr id="75" name="TextBox 74"/>
          <p:cNvSpPr txBox="1"/>
          <p:nvPr/>
        </p:nvSpPr>
        <p:spPr>
          <a:xfrm>
            <a:off x="2392289" y="6219183"/>
            <a:ext cx="5593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76" name="TextBox 75"/>
          <p:cNvSpPr txBox="1"/>
          <p:nvPr/>
        </p:nvSpPr>
        <p:spPr>
          <a:xfrm>
            <a:off x="4258937" y="6219183"/>
            <a:ext cx="55933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78" name="TextBox 77"/>
          <p:cNvSpPr txBox="1"/>
          <p:nvPr/>
        </p:nvSpPr>
        <p:spPr>
          <a:xfrm>
            <a:off x="4757525" y="5291091"/>
            <a:ext cx="57992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6.8%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2653399" y="-89020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 </a:t>
            </a:r>
            <a:endParaRPr 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3807946" y="-83166"/>
            <a:ext cx="2147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T cells+ </a:t>
            </a:r>
            <a:r>
              <a:rPr lang="en-US" sz="1400" dirty="0" err="1" smtClean="0"/>
              <a:t>lenalidomide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48" name="TextBox 47"/>
          <p:cNvSpPr txBox="1"/>
          <p:nvPr/>
        </p:nvSpPr>
        <p:spPr>
          <a:xfrm>
            <a:off x="2666054" y="1576212"/>
            <a:ext cx="19307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D107a- PE-CF594</a:t>
            </a:r>
            <a:endParaRPr lang="en-US" sz="16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089102" y="3250930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NFα- A700</a:t>
            </a:r>
            <a:endParaRPr lang="en-US" sz="16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089102" y="4993329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 smtClean="0"/>
              <a:t>IFNγ</a:t>
            </a:r>
            <a:r>
              <a:rPr lang="en-US" sz="1600" b="1" dirty="0" smtClean="0"/>
              <a:t>- V450</a:t>
            </a:r>
            <a:endParaRPr lang="en-US" sz="16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3391027" y="6586411"/>
            <a:ext cx="1559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IL-2</a:t>
            </a:r>
            <a:endParaRPr lang="en-US" sz="16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0" y="0"/>
            <a:ext cx="2269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</a:p>
          <a:p>
            <a:r>
              <a:rPr lang="en-US" b="1" dirty="0" smtClean="0"/>
              <a:t>Fig. </a:t>
            </a:r>
            <a:r>
              <a:rPr lang="en-US" b="1" dirty="0" smtClean="0"/>
              <a:t>10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11505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 rotWithShape="1">
          <a:blip r:embed="rId2"/>
          <a:srcRect l="9308" b="5799"/>
          <a:stretch/>
        </p:blipFill>
        <p:spPr>
          <a:xfrm>
            <a:off x="392081" y="3776732"/>
            <a:ext cx="2194684" cy="22321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749" y="0"/>
            <a:ext cx="226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</a:t>
            </a:r>
            <a:r>
              <a:rPr lang="en-US" b="1" dirty="0"/>
              <a:t>2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10665" b="3976"/>
          <a:stretch/>
        </p:blipFill>
        <p:spPr>
          <a:xfrm>
            <a:off x="394549" y="1183583"/>
            <a:ext cx="2194684" cy="22442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l="8599" b="5527"/>
          <a:stretch/>
        </p:blipFill>
        <p:spPr>
          <a:xfrm>
            <a:off x="3156399" y="1183583"/>
            <a:ext cx="2293321" cy="224429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9486" b="5217"/>
          <a:stretch/>
        </p:blipFill>
        <p:spPr>
          <a:xfrm>
            <a:off x="6312797" y="1183583"/>
            <a:ext cx="2293321" cy="224429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85065" y="1656554"/>
            <a:ext cx="989047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Lymphocytes:89.1%</a:t>
            </a:r>
            <a:endParaRPr lang="en-US" sz="1100" dirty="0"/>
          </a:p>
        </p:txBody>
      </p:sp>
      <p:sp>
        <p:nvSpPr>
          <p:cNvPr id="13" name="TextBox 12"/>
          <p:cNvSpPr txBox="1"/>
          <p:nvPr/>
        </p:nvSpPr>
        <p:spPr>
          <a:xfrm>
            <a:off x="3725336" y="1525749"/>
            <a:ext cx="142847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Single cells: 99.8%</a:t>
            </a:r>
            <a:endParaRPr lang="en-US" sz="1100" dirty="0"/>
          </a:p>
        </p:txBody>
      </p:sp>
      <p:sp>
        <p:nvSpPr>
          <p:cNvPr id="16" name="TextBox 15"/>
          <p:cNvSpPr txBox="1"/>
          <p:nvPr/>
        </p:nvSpPr>
        <p:spPr>
          <a:xfrm>
            <a:off x="6750552" y="1525749"/>
            <a:ext cx="142847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Live cells: 86.8%</a:t>
            </a:r>
            <a:endParaRPr lang="en-US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6750552" y="1285751"/>
            <a:ext cx="142847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18" name="TextBox 17"/>
          <p:cNvSpPr txBox="1"/>
          <p:nvPr/>
        </p:nvSpPr>
        <p:spPr>
          <a:xfrm>
            <a:off x="712189" y="3906838"/>
            <a:ext cx="181413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D5+CD19+ (CLL): 91.5%</a:t>
            </a:r>
            <a:endParaRPr lang="en-US" sz="1100" dirty="0"/>
          </a:p>
        </p:txBody>
      </p:sp>
      <p:sp>
        <p:nvSpPr>
          <p:cNvPr id="19" name="TextBox 18"/>
          <p:cNvSpPr txBox="1"/>
          <p:nvPr/>
        </p:nvSpPr>
        <p:spPr>
          <a:xfrm>
            <a:off x="779091" y="4211724"/>
            <a:ext cx="28269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100" dirty="0"/>
          </a:p>
        </p:txBody>
      </p:sp>
      <p:sp>
        <p:nvSpPr>
          <p:cNvPr id="20" name="TextBox 19"/>
          <p:cNvSpPr txBox="1"/>
          <p:nvPr/>
        </p:nvSpPr>
        <p:spPr>
          <a:xfrm>
            <a:off x="1300781" y="3330235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4031806" y="3323334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-H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6946055" y="3330235"/>
            <a:ext cx="1660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ive/Dead- aqua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1090842" y="5879878"/>
            <a:ext cx="1660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5- FITC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-262265" y="1795964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SC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2435577" y="1803824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-W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5660890" y="1795964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-262265" y="4631166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19- V450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217134" y="500604"/>
            <a:ext cx="427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pic>
        <p:nvPicPr>
          <p:cNvPr id="3" name="Picture 2"/>
          <p:cNvPicPr>
            <a:picLocks/>
          </p:cNvPicPr>
          <p:nvPr/>
        </p:nvPicPr>
        <p:blipFill rotWithShape="1">
          <a:blip r:embed="rId6"/>
          <a:srcRect l="7089" b="4931"/>
          <a:stretch/>
        </p:blipFill>
        <p:spPr>
          <a:xfrm>
            <a:off x="3172078" y="3776732"/>
            <a:ext cx="2371712" cy="2247868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 rot="16200000">
            <a:off x="2444858" y="4319445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</a:t>
            </a:r>
            <a:endParaRPr lang="en-US" sz="1400" dirty="0"/>
          </a:p>
        </p:txBody>
      </p:sp>
      <p:sp>
        <p:nvSpPr>
          <p:cNvPr id="30" name="TextBox 29"/>
          <p:cNvSpPr txBox="1"/>
          <p:nvPr/>
        </p:nvSpPr>
        <p:spPr>
          <a:xfrm>
            <a:off x="4161202" y="5880482"/>
            <a:ext cx="1660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3- BV650</a:t>
            </a:r>
            <a:endParaRPr lang="en-US" sz="1400" dirty="0"/>
          </a:p>
        </p:txBody>
      </p:sp>
      <p:sp>
        <p:nvSpPr>
          <p:cNvPr id="31" name="TextBox 30"/>
          <p:cNvSpPr txBox="1"/>
          <p:nvPr/>
        </p:nvSpPr>
        <p:spPr>
          <a:xfrm>
            <a:off x="4052607" y="4528708"/>
            <a:ext cx="142847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T cells</a:t>
            </a:r>
            <a:r>
              <a:rPr lang="en-US" sz="1100" dirty="0" smtClean="0"/>
              <a:t>: 33.4%</a:t>
            </a:r>
            <a:endParaRPr lang="en-US" sz="11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7"/>
          <a:srcRect l="10496" b="4454"/>
          <a:stretch/>
        </p:blipFill>
        <p:spPr>
          <a:xfrm>
            <a:off x="6312797" y="3776791"/>
            <a:ext cx="2232336" cy="2247809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6614288" y="3955479"/>
            <a:ext cx="142847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XCR4+: 99.9%</a:t>
            </a:r>
            <a:endParaRPr lang="en-US" sz="11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5660890" y="4323974"/>
            <a:ext cx="1146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SC</a:t>
            </a:r>
            <a:endParaRPr 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7118167" y="5885011"/>
            <a:ext cx="16600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XCR4</a:t>
            </a:r>
            <a:r>
              <a:rPr lang="en-US" sz="1400" dirty="0" smtClean="0"/>
              <a:t>- BV605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297090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11070" b="13061"/>
          <a:stretch/>
        </p:blipFill>
        <p:spPr>
          <a:xfrm>
            <a:off x="5987663" y="197038"/>
            <a:ext cx="2583930" cy="258054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10673" b="12476"/>
          <a:stretch/>
        </p:blipFill>
        <p:spPr>
          <a:xfrm>
            <a:off x="3134648" y="228832"/>
            <a:ext cx="2599018" cy="256298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l="10056" b="13867"/>
          <a:stretch/>
        </p:blipFill>
        <p:spPr>
          <a:xfrm>
            <a:off x="290449" y="238463"/>
            <a:ext cx="2578257" cy="247120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990600" y="195413"/>
            <a:ext cx="2845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L sample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441375" y="195413"/>
            <a:ext cx="223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L</a:t>
            </a:r>
            <a:r>
              <a:rPr lang="en-US" dirty="0"/>
              <a:t>+</a:t>
            </a:r>
            <a:r>
              <a:rPr lang="en-US" dirty="0" smtClean="0"/>
              <a:t> </a:t>
            </a:r>
            <a:r>
              <a:rPr lang="en-US" dirty="0" err="1" smtClean="0"/>
              <a:t>cucurbitacin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476604" y="165531"/>
            <a:ext cx="2138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L+lenalidomide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859189" y="689440"/>
            <a:ext cx="78873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78.6%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503415" y="656162"/>
            <a:ext cx="78873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66.1%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7469095" y="689440"/>
            <a:ext cx="78873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7</a:t>
            </a:r>
            <a:r>
              <a:rPr lang="en-US" dirty="0" smtClean="0"/>
              <a:t>6.9%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483100" y="446269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204140" y="2767816"/>
            <a:ext cx="8612816" cy="247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V="1">
            <a:off x="204140" y="564746"/>
            <a:ext cx="26784" cy="220307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 rot="16200000">
            <a:off x="-233385" y="1389191"/>
            <a:ext cx="635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SC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3898605" y="2782457"/>
            <a:ext cx="2089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Live/dead-aqua</a:t>
            </a:r>
            <a:endParaRPr lang="en-US" dirty="0"/>
          </a:p>
        </p:txBody>
      </p:sp>
      <p:pic>
        <p:nvPicPr>
          <p:cNvPr id="8" name="Picture 7" descr="Viability Curcubitacin lenalidomide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10"/>
          <a:stretch/>
        </p:blipFill>
        <p:spPr>
          <a:xfrm>
            <a:off x="23749" y="3077882"/>
            <a:ext cx="4459351" cy="1973784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68059" y="151768"/>
            <a:ext cx="366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.</a:t>
            </a:r>
            <a:endParaRPr lang="en-US" dirty="0"/>
          </a:p>
        </p:txBody>
      </p:sp>
      <p:pic>
        <p:nvPicPr>
          <p:cNvPr id="7" name="Picture 6" descr="Viability Curcubitacin lenalidomide- 15h- IL-10.pdf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804" b="22788"/>
          <a:stretch/>
        </p:blipFill>
        <p:spPr>
          <a:xfrm>
            <a:off x="-2999" y="4945529"/>
            <a:ext cx="3642414" cy="1912471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449294" y="2893216"/>
            <a:ext cx="604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h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1449293" y="4867000"/>
            <a:ext cx="844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2-15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9999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6909" b="4172"/>
          <a:stretch/>
        </p:blipFill>
        <p:spPr>
          <a:xfrm>
            <a:off x="667732" y="747806"/>
            <a:ext cx="2559562" cy="256913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6909" b="4172"/>
          <a:stretch/>
        </p:blipFill>
        <p:spPr>
          <a:xfrm>
            <a:off x="6055989" y="732865"/>
            <a:ext cx="2559562" cy="256913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l="7275" b="5299"/>
          <a:stretch/>
        </p:blipFill>
        <p:spPr>
          <a:xfrm>
            <a:off x="3301999" y="747806"/>
            <a:ext cx="2534833" cy="2524312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>
            <a:off x="694516" y="3316941"/>
            <a:ext cx="8389499" cy="247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682673" y="792629"/>
            <a:ext cx="26784" cy="252431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-1410" y="1764045"/>
            <a:ext cx="9689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-AAD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697798" y="3393361"/>
            <a:ext cx="20890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Annexin</a:t>
            </a:r>
            <a:r>
              <a:rPr lang="en-US" dirty="0" smtClean="0"/>
              <a:t>- FITC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8059" y="225295"/>
            <a:ext cx="366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.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364130" y="380079"/>
            <a:ext cx="2845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L sample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604305" y="373850"/>
            <a:ext cx="223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L</a:t>
            </a:r>
            <a:r>
              <a:rPr lang="en-US" dirty="0"/>
              <a:t>+</a:t>
            </a:r>
            <a:r>
              <a:rPr lang="en-US" dirty="0" smtClean="0"/>
              <a:t> </a:t>
            </a:r>
            <a:r>
              <a:rPr lang="en-US" dirty="0" err="1" smtClean="0"/>
              <a:t>cucurbitacin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476604" y="373850"/>
            <a:ext cx="2138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L+lenalidomide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075766" y="926352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.27%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1060824" y="2722281"/>
            <a:ext cx="76932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9.3%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2472908" y="907515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9.81%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2472908" y="2722281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0.6%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3693951" y="897377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.77%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3679009" y="2693306"/>
            <a:ext cx="76932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68.5%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5091093" y="878540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6.8%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5091093" y="2693306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3.9%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6449082" y="912318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.53%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6434140" y="2708247"/>
            <a:ext cx="76932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75.8%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7846224" y="893481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1.3%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7846224" y="2708247"/>
            <a:ext cx="7543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2.4%</a:t>
            </a:r>
            <a:endParaRPr lang="en-US" sz="1200" dirty="0"/>
          </a:p>
        </p:txBody>
      </p:sp>
      <p:pic>
        <p:nvPicPr>
          <p:cNvPr id="29" name="Picture 28" descr="Viability  STAT3 knockout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8"/>
          <a:stretch/>
        </p:blipFill>
        <p:spPr>
          <a:xfrm>
            <a:off x="1215118" y="4083658"/>
            <a:ext cx="4037106" cy="2774342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324503" y="4083658"/>
            <a:ext cx="384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98176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749" y="0"/>
            <a:ext cx="226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</a:t>
            </a:r>
            <a:r>
              <a:rPr lang="en-US" b="1" dirty="0"/>
              <a:t>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r="62092" b="5964"/>
          <a:stretch/>
        </p:blipFill>
        <p:spPr>
          <a:xfrm>
            <a:off x="-164352" y="446809"/>
            <a:ext cx="2457674" cy="209802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20920" y="572249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 188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 baseline                                                     509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</a:t>
            </a:r>
            <a:r>
              <a:rPr lang="en-US" dirty="0" err="1" smtClean="0"/>
              <a:t>curcurbitacin</a:t>
            </a:r>
            <a:r>
              <a:rPr lang="en-US" dirty="0"/>
              <a:t> </a:t>
            </a:r>
            <a:r>
              <a:rPr lang="en-US" dirty="0" smtClean="0"/>
              <a:t>(0.05μM)                        504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</a:t>
            </a:r>
            <a:r>
              <a:rPr lang="en-US" dirty="0" err="1" smtClean="0"/>
              <a:t>lenalidomide</a:t>
            </a:r>
            <a:r>
              <a:rPr lang="en-US" dirty="0"/>
              <a:t> (</a:t>
            </a:r>
            <a:r>
              <a:rPr lang="en-US" dirty="0" smtClean="0"/>
              <a:t>10μM)                            564</a:t>
            </a:r>
          </a:p>
          <a:p>
            <a:pPr>
              <a:lnSpc>
                <a:spcPct val="120000"/>
              </a:lnSpc>
            </a:pP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86811" y="4597958"/>
            <a:ext cx="18746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AT3- P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487765" y="320016"/>
            <a:ext cx="653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FI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4801" r="63308" b="3009"/>
          <a:stretch/>
        </p:blipFill>
        <p:spPr>
          <a:xfrm>
            <a:off x="135597" y="2683929"/>
            <a:ext cx="2189081" cy="211437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620920" y="2959191"/>
            <a:ext cx="6451481" cy="174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err="1" smtClean="0"/>
              <a:t>Isotype</a:t>
            </a:r>
            <a:r>
              <a:rPr lang="en-US" dirty="0" smtClean="0"/>
              <a:t>                                                              188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 baseline                                                     654                                                         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</a:t>
            </a:r>
            <a:r>
              <a:rPr lang="en-US" dirty="0" err="1" smtClean="0"/>
              <a:t>curcurbitacin</a:t>
            </a:r>
            <a:r>
              <a:rPr lang="en-US" dirty="0" smtClean="0"/>
              <a:t> </a:t>
            </a:r>
            <a:r>
              <a:rPr lang="en-US" dirty="0"/>
              <a:t>(</a:t>
            </a:r>
            <a:r>
              <a:rPr lang="en-US" dirty="0" smtClean="0"/>
              <a:t>0.05μM)                         658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</a:t>
            </a:r>
            <a:r>
              <a:rPr lang="en-US" dirty="0" err="1" smtClean="0"/>
              <a:t>lenalidomide</a:t>
            </a:r>
            <a:r>
              <a:rPr lang="en-US" dirty="0"/>
              <a:t> </a:t>
            </a:r>
            <a:r>
              <a:rPr lang="en-US" dirty="0" smtClean="0"/>
              <a:t>(10μM)                            666</a:t>
            </a:r>
          </a:p>
          <a:p>
            <a:pPr>
              <a:lnSpc>
                <a:spcPct val="120000"/>
              </a:lnSpc>
            </a:pP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55781" y="194576"/>
            <a:ext cx="1258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 hours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55781" y="2419391"/>
            <a:ext cx="1258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2 hours</a:t>
            </a:r>
            <a:endParaRPr lang="en-US" dirty="0"/>
          </a:p>
        </p:txBody>
      </p:sp>
      <p:pic>
        <p:nvPicPr>
          <p:cNvPr id="14" name="Picture 13" descr="total STAT3 curcurbitacin lenalidomide 24 hours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00"/>
          <a:stretch/>
        </p:blipFill>
        <p:spPr>
          <a:xfrm>
            <a:off x="3881914" y="4861084"/>
            <a:ext cx="5279988" cy="2248107"/>
          </a:xfrm>
          <a:prstGeom prst="rect">
            <a:avLst/>
          </a:prstGeom>
        </p:spPr>
      </p:pic>
      <p:pic>
        <p:nvPicPr>
          <p:cNvPr id="15" name="Picture 14" descr="total STAT3 curcurbitacin lenalidomide 2 hours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47" r="29008"/>
          <a:stretch/>
        </p:blipFill>
        <p:spPr>
          <a:xfrm>
            <a:off x="889070" y="4861082"/>
            <a:ext cx="3726133" cy="2034164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324678" y="4704284"/>
            <a:ext cx="1258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 hours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5434779" y="4704284"/>
            <a:ext cx="1258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2 hour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17890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26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. 4</a:t>
            </a:r>
            <a:endParaRPr lang="en-US" b="1" dirty="0"/>
          </a:p>
        </p:txBody>
      </p:sp>
      <p:pic>
        <p:nvPicPr>
          <p:cNvPr id="5" name="Picture 4" descr="IL-10 ELISA- CXCL12 only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432"/>
          <a:stretch/>
        </p:blipFill>
        <p:spPr>
          <a:xfrm>
            <a:off x="1736929" y="1294328"/>
            <a:ext cx="5590975" cy="3068496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2663321" y="1372859"/>
            <a:ext cx="139452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024910" y="1134004"/>
            <a:ext cx="13939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P=0.004</a:t>
            </a:r>
            <a:endParaRPr lang="en-US" sz="1100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4061953" y="1324210"/>
            <a:ext cx="0" cy="11141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2663321" y="1315047"/>
            <a:ext cx="0" cy="11141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8059" y="615035"/>
            <a:ext cx="376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24453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3629462" y="3305469"/>
            <a:ext cx="341908" cy="255719"/>
          </a:xfrm>
          <a:prstGeom prst="rect">
            <a:avLst/>
          </a:prstGeom>
          <a:solidFill>
            <a:schemeClr val="tx1">
              <a:alpha val="33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4152024" y="2514600"/>
            <a:ext cx="4639735" cy="1080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20000"/>
              </a:lnSpc>
            </a:pPr>
            <a:r>
              <a:rPr lang="en-US" dirty="0" smtClean="0"/>
              <a:t>FMO                                                                    13.4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 baseline                                                       221</a:t>
            </a:r>
          </a:p>
          <a:p>
            <a:pPr>
              <a:lnSpc>
                <a:spcPct val="120000"/>
              </a:lnSpc>
            </a:pPr>
            <a:r>
              <a:rPr lang="en-US" dirty="0" smtClean="0"/>
              <a:t>CLL+ </a:t>
            </a:r>
            <a:r>
              <a:rPr lang="en-US" dirty="0" err="1" smtClean="0"/>
              <a:t>CpG</a:t>
            </a:r>
            <a:r>
              <a:rPr lang="en-US" dirty="0" smtClean="0"/>
              <a:t>                                                            516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52400" y="95833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937252" y="4250764"/>
            <a:ext cx="198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-S727-STAT3- PE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4901" r="66608" b="14065"/>
          <a:stretch/>
        </p:blipFill>
        <p:spPr>
          <a:xfrm>
            <a:off x="381000" y="1143000"/>
            <a:ext cx="3062379" cy="3187394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3629462" y="2971800"/>
            <a:ext cx="341908" cy="255719"/>
          </a:xfrm>
          <a:prstGeom prst="rect">
            <a:avLst/>
          </a:prstGeom>
          <a:solidFill>
            <a:schemeClr val="bg1">
              <a:lumMod val="85000"/>
              <a:alpha val="40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3629462" y="2642459"/>
            <a:ext cx="341908" cy="25571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8105998" y="2263630"/>
            <a:ext cx="76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FI</a:t>
            </a:r>
          </a:p>
        </p:txBody>
      </p:sp>
    </p:spTree>
    <p:extLst>
      <p:ext uri="{BB962C8B-B14F-4D97-AF65-F5344CB8AC3E}">
        <p14:creationId xmlns:p14="http://schemas.microsoft.com/office/powerpoint/2010/main" val="128575540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/>
          <a:srcRect l="12365" b="12476"/>
          <a:stretch/>
        </p:blipFill>
        <p:spPr>
          <a:xfrm>
            <a:off x="4645244" y="892860"/>
            <a:ext cx="2394172" cy="251139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3"/>
          <a:srcRect l="9777" b="13282"/>
          <a:stretch/>
        </p:blipFill>
        <p:spPr>
          <a:xfrm>
            <a:off x="2362200" y="873397"/>
            <a:ext cx="2438400" cy="253085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06246" y="789657"/>
            <a:ext cx="1339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Isotype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360378" y="777899"/>
            <a:ext cx="1456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I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181600" y="789657"/>
            <a:ext cx="1456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IB+ CXCL12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617923" y="789657"/>
            <a:ext cx="1456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IB+ </a:t>
            </a:r>
            <a:r>
              <a:rPr lang="en-US" dirty="0" err="1" smtClean="0"/>
              <a:t>CpG</a:t>
            </a:r>
            <a:endParaRPr lang="en-US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176075" y="3393346"/>
            <a:ext cx="8967925" cy="247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176075" y="778610"/>
            <a:ext cx="0" cy="26147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-255948" y="1888533"/>
            <a:ext cx="635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SC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57508" y="3384529"/>
            <a:ext cx="15873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L-10- APC</a:t>
            </a:r>
            <a:endParaRPr lang="en-US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/>
          <a:srcRect l="10899" b="12414"/>
          <a:stretch/>
        </p:blipFill>
        <p:spPr>
          <a:xfrm>
            <a:off x="6905496" y="889492"/>
            <a:ext cx="2383501" cy="252856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5"/>
          <a:srcRect l="10215" b="13405"/>
          <a:stretch/>
        </p:blipFill>
        <p:spPr>
          <a:xfrm>
            <a:off x="146969" y="897949"/>
            <a:ext cx="2462782" cy="2494724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575764" y="1340170"/>
            <a:ext cx="5819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0.17%</a:t>
            </a:r>
            <a:endParaRPr lang="en-US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3796182" y="1339749"/>
            <a:ext cx="58196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.03%</a:t>
            </a:r>
          </a:p>
          <a:p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8305800" y="1339749"/>
            <a:ext cx="5819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3.01%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5842330" y="1340170"/>
            <a:ext cx="58196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.22%</a:t>
            </a:r>
          </a:p>
          <a:p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4305300" y="3810000"/>
            <a:ext cx="990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P=0.01</a:t>
            </a:r>
            <a:endParaRPr lang="en-US" sz="16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4204398" y="4122137"/>
            <a:ext cx="93540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204398" y="4080047"/>
            <a:ext cx="0" cy="8418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5139801" y="4080047"/>
            <a:ext cx="0" cy="8418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76075" y="39510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.</a:t>
            </a:r>
            <a:endParaRPr lang="en-US" dirty="0"/>
          </a:p>
        </p:txBody>
      </p:sp>
      <p:pic>
        <p:nvPicPr>
          <p:cNvPr id="2" name="Picture 1" descr="IL-10 IC staining- HC.pdf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05"/>
          <a:stretch/>
        </p:blipFill>
        <p:spPr>
          <a:xfrm>
            <a:off x="2782003" y="4320768"/>
            <a:ext cx="5207089" cy="2372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3262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orrelation of IL-10 IC CXCR4 MFI-XY Data [CXCR4]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4514" y="1546744"/>
            <a:ext cx="3761485" cy="279990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rot="20011740">
            <a:off x="4399493" y="1830701"/>
            <a:ext cx="13335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r</a:t>
            </a:r>
            <a:r>
              <a:rPr lang="en-US" sz="1100" dirty="0" smtClean="0"/>
              <a:t>=0.72</a:t>
            </a:r>
            <a:endParaRPr lang="en-US" sz="1100" dirty="0"/>
          </a:p>
        </p:txBody>
      </p:sp>
      <p:sp>
        <p:nvSpPr>
          <p:cNvPr id="7" name="TextBox 6"/>
          <p:cNvSpPr txBox="1"/>
          <p:nvPr/>
        </p:nvSpPr>
        <p:spPr>
          <a:xfrm>
            <a:off x="3083305" y="3316632"/>
            <a:ext cx="13335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P=0.0002</a:t>
            </a:r>
            <a:endParaRPr lang="en-US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22695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</a:t>
            </a:r>
          </a:p>
          <a:p>
            <a:r>
              <a:rPr lang="en-US" b="1" dirty="0" smtClean="0"/>
              <a:t>Fig. 5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8222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350D933D1F0B94BBAB0BD440E363FC8" ma:contentTypeVersion="7" ma:contentTypeDescription="Create a new document." ma:contentTypeScope="" ma:versionID="9b91d12c69b0b06fb5fc5553a5ae3899">
  <xsd:schema xmlns:xsd="http://www.w3.org/2001/XMLSchema" xmlns:p="http://schemas.microsoft.com/office/2006/metadata/properties" xmlns:ns2="d3c69c58-74ff-44a8-9788-42871589f19e" targetNamespace="http://schemas.microsoft.com/office/2006/metadata/properties" ma:root="true" ma:fieldsID="019318177470c37874020093bc95e111" ns2:_="">
    <xsd:import namespace="d3c69c58-74ff-44a8-9788-42871589f19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c69c58-74ff-44a8-9788-42871589f19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d3c69c58-74ff-44a8-9788-42871589f19e" xsi:nil="true"/>
    <DocumentId xmlns="d3c69c58-74ff-44a8-9788-42871589f19e">Presentation 1.PPTX</DocumentId>
    <DocumentType xmlns="d3c69c58-74ff-44a8-9788-42871589f19e">Presentation</DocumentType>
    <FileFormat xmlns="d3c69c58-74ff-44a8-9788-42871589f19e">PPTX</FileFormat>
    <Checked_x0020_Out_x0020_To xmlns="d3c69c58-74ff-44a8-9788-42871589f19e">
      <UserInfo>
        <DisplayName/>
        <AccountId xsi:nil="true"/>
        <AccountType/>
      </UserInfo>
    </Checked_x0020_Out_x0020_To>
    <TitleName xmlns="d3c69c58-74ff-44a8-9788-42871589f19e">Presentation 1.PPTX</TitleName>
    <IsDeleted xmlns="d3c69c58-74ff-44a8-9788-42871589f19e">false</IsDeleted>
  </documentManagement>
</p:properties>
</file>

<file path=customXml/itemProps1.xml><?xml version="1.0" encoding="utf-8"?>
<ds:datastoreItem xmlns:ds="http://schemas.openxmlformats.org/officeDocument/2006/customXml" ds:itemID="{17A0BC4D-2F85-4B8A-8908-11AEF5229B80}"/>
</file>

<file path=customXml/itemProps2.xml><?xml version="1.0" encoding="utf-8"?>
<ds:datastoreItem xmlns:ds="http://schemas.openxmlformats.org/officeDocument/2006/customXml" ds:itemID="{270EBAEF-F25B-42CD-B730-E0A81E2F2F14}"/>
</file>

<file path=customXml/itemProps3.xml><?xml version="1.0" encoding="utf-8"?>
<ds:datastoreItem xmlns:ds="http://schemas.openxmlformats.org/officeDocument/2006/customXml" ds:itemID="{B48F860E-2113-4436-861F-5BDE3090521A}"/>
</file>

<file path=docProps/app.xml><?xml version="1.0" encoding="utf-8"?>
<Properties xmlns="http://schemas.openxmlformats.org/officeDocument/2006/extended-properties" xmlns:vt="http://schemas.openxmlformats.org/officeDocument/2006/docPropsVTypes">
  <TotalTime>55106</TotalTime>
  <Words>523</Words>
  <Application>Microsoft Macintosh PowerPoint</Application>
  <PresentationFormat>On-screen Show (4:3)</PresentationFormat>
  <Paragraphs>178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ilka Shaim</dc:creator>
  <cp:lastModifiedBy>Hila shaim</cp:lastModifiedBy>
  <cp:revision>113</cp:revision>
  <dcterms:created xsi:type="dcterms:W3CDTF">2015-09-29T04:17:47Z</dcterms:created>
  <dcterms:modified xsi:type="dcterms:W3CDTF">2017-11-14T05:16:58Z</dcterms:modified>
</cp:coreProperties>
</file>